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9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Bioedit" initials="b" lastIdx="5" clrIdx="0">
    <p:extLst>
      <p:ext uri="{19B8F6BF-5375-455C-9EA6-DF929625EA0E}">
        <p15:presenceInfo xmlns:p15="http://schemas.microsoft.com/office/powerpoint/2012/main" userId="Bioedit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A488322-F2BA-4B5B-9748-0D474271808F}" styleName="中間スタイル 3 - アクセント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6E25E649-3F16-4E02-A733-19D2CDBF48F0}" styleName="中間スタイル 3 - アクセント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EC20E35-A176-4012-BC5E-935CFFF8708E}" styleName="スタイル (中間)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F2DE63D5-997A-4646-A377-4702673A728D}" styleName="淡色スタイル 2 - アクセント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69012ECD-51FC-41F1-AA8D-1B2483CD663E}" styleName="淡色スタイル 2 - アクセント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ABFCF23-3B69-468F-B69F-88F6DE6A72F2}" styleName="中間スタイル 1 - アクセント 5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5">
              <a:tint val="20000"/>
            </a:schemeClr>
          </a:solidFill>
        </a:fill>
      </a:tcStyle>
    </a:band1H>
    <a:band1V>
      <a:tcStyle>
        <a:tcBdr/>
        <a:fill>
          <a:solidFill>
            <a:schemeClr val="accent5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Row>
  </a:tblStyle>
  <a:tblStyle styleId="{793D81CF-94F2-401A-BA57-92F5A7B2D0C5}" styleName="スタイル (中間)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3B4B98B0-60AC-42C2-AFA5-B58CD77FA1E5}" styleName="淡色スタイル 1 - アクセント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59" autoAdjust="0"/>
    <p:restoredTop sz="94630"/>
  </p:normalViewPr>
  <p:slideViewPr>
    <p:cSldViewPr snapToGrid="0" snapToObjects="1">
      <p:cViewPr varScale="1">
        <p:scale>
          <a:sx n="64" d="100"/>
          <a:sy n="64" d="100"/>
        </p:scale>
        <p:origin x="2856" y="16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E9DE772-56E2-1F44-9DD7-5841D22FBD60}" type="datetimeFigureOut">
              <a:rPr kumimoji="1" lang="ja-JP" altLang="en-US" smtClean="0"/>
              <a:t>2021/12/1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18CFE91-274D-6E47-BF13-65C92B09029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84883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F6AF4D-3DAB-E043-BCEB-DFC456E76B0E}" type="datetimeFigureOut">
              <a:rPr kumimoji="1" lang="ja-JP" altLang="en-US" smtClean="0"/>
              <a:t>2021/1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070484-20E0-9945-A30D-B3F1859FB0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4344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F6AF4D-3DAB-E043-BCEB-DFC456E76B0E}" type="datetimeFigureOut">
              <a:rPr kumimoji="1" lang="ja-JP" altLang="en-US" smtClean="0"/>
              <a:t>2021/1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070484-20E0-9945-A30D-B3F1859FB0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0737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F6AF4D-3DAB-E043-BCEB-DFC456E76B0E}" type="datetimeFigureOut">
              <a:rPr kumimoji="1" lang="ja-JP" altLang="en-US" smtClean="0"/>
              <a:t>2021/1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070484-20E0-9945-A30D-B3F1859FB0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35573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F6AF4D-3DAB-E043-BCEB-DFC456E76B0E}" type="datetimeFigureOut">
              <a:rPr kumimoji="1" lang="ja-JP" altLang="en-US" smtClean="0"/>
              <a:t>2021/1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070484-20E0-9945-A30D-B3F1859FB0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98463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F6AF4D-3DAB-E043-BCEB-DFC456E76B0E}" type="datetimeFigureOut">
              <a:rPr kumimoji="1" lang="ja-JP" altLang="en-US" smtClean="0"/>
              <a:t>2021/1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070484-20E0-9945-A30D-B3F1859FB0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06943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F6AF4D-3DAB-E043-BCEB-DFC456E76B0E}" type="datetimeFigureOut">
              <a:rPr kumimoji="1" lang="ja-JP" altLang="en-US" smtClean="0"/>
              <a:t>2021/12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070484-20E0-9945-A30D-B3F1859FB0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5807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F6AF4D-3DAB-E043-BCEB-DFC456E76B0E}" type="datetimeFigureOut">
              <a:rPr kumimoji="1" lang="ja-JP" altLang="en-US" smtClean="0"/>
              <a:t>2021/12/1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070484-20E0-9945-A30D-B3F1859FB0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10063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F6AF4D-3DAB-E043-BCEB-DFC456E76B0E}" type="datetimeFigureOut">
              <a:rPr kumimoji="1" lang="ja-JP" altLang="en-US" smtClean="0"/>
              <a:t>2021/12/1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070484-20E0-9945-A30D-B3F1859FB0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15041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F6AF4D-3DAB-E043-BCEB-DFC456E76B0E}" type="datetimeFigureOut">
              <a:rPr kumimoji="1" lang="ja-JP" altLang="en-US" smtClean="0"/>
              <a:t>2021/12/1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070484-20E0-9945-A30D-B3F1859FB0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93179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F6AF4D-3DAB-E043-BCEB-DFC456E76B0E}" type="datetimeFigureOut">
              <a:rPr kumimoji="1" lang="ja-JP" altLang="en-US" smtClean="0"/>
              <a:t>2021/12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070484-20E0-9945-A30D-B3F1859FB0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33316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F6AF4D-3DAB-E043-BCEB-DFC456E76B0E}" type="datetimeFigureOut">
              <a:rPr kumimoji="1" lang="ja-JP" altLang="en-US" smtClean="0"/>
              <a:t>2021/12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070484-20E0-9945-A30D-B3F1859FB0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19903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F6AF4D-3DAB-E043-BCEB-DFC456E76B0E}" type="datetimeFigureOut">
              <a:rPr kumimoji="1" lang="ja-JP" altLang="en-US" smtClean="0"/>
              <a:t>2021/1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070484-20E0-9945-A30D-B3F1859FB00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73011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2AE21A07-408E-7D4F-BD03-BDEB5781952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90192164"/>
              </p:ext>
            </p:extLst>
          </p:nvPr>
        </p:nvGraphicFramePr>
        <p:xfrm>
          <a:off x="636486" y="2864224"/>
          <a:ext cx="5716861" cy="2245655"/>
        </p:xfrm>
        <a:graphic>
          <a:graphicData uri="http://schemas.openxmlformats.org/drawingml/2006/table">
            <a:tbl>
              <a:tblPr/>
              <a:tblGrid>
                <a:gridCol w="969882">
                  <a:extLst>
                    <a:ext uri="{9D8B030D-6E8A-4147-A177-3AD203B41FA5}">
                      <a16:colId xmlns:a16="http://schemas.microsoft.com/office/drawing/2014/main" val="2730542016"/>
                    </a:ext>
                  </a:extLst>
                </a:gridCol>
                <a:gridCol w="32544">
                  <a:extLst>
                    <a:ext uri="{9D8B030D-6E8A-4147-A177-3AD203B41FA5}">
                      <a16:colId xmlns:a16="http://schemas.microsoft.com/office/drawing/2014/main" val="1773405051"/>
                    </a:ext>
                  </a:extLst>
                </a:gridCol>
                <a:gridCol w="973672">
                  <a:extLst>
                    <a:ext uri="{9D8B030D-6E8A-4147-A177-3AD203B41FA5}">
                      <a16:colId xmlns:a16="http://schemas.microsoft.com/office/drawing/2014/main" val="1485943092"/>
                    </a:ext>
                  </a:extLst>
                </a:gridCol>
                <a:gridCol w="1207337">
                  <a:extLst>
                    <a:ext uri="{9D8B030D-6E8A-4147-A177-3AD203B41FA5}">
                      <a16:colId xmlns:a16="http://schemas.microsoft.com/office/drawing/2014/main" val="2954708159"/>
                    </a:ext>
                  </a:extLst>
                </a:gridCol>
                <a:gridCol w="1290918">
                  <a:extLst>
                    <a:ext uri="{9D8B030D-6E8A-4147-A177-3AD203B41FA5}">
                      <a16:colId xmlns:a16="http://schemas.microsoft.com/office/drawing/2014/main" val="3284666572"/>
                    </a:ext>
                  </a:extLst>
                </a:gridCol>
                <a:gridCol w="1242508">
                  <a:extLst>
                    <a:ext uri="{9D8B030D-6E8A-4147-A177-3AD203B41FA5}">
                      <a16:colId xmlns:a16="http://schemas.microsoft.com/office/drawing/2014/main" val="548890077"/>
                    </a:ext>
                  </a:extLst>
                </a:gridCol>
              </a:tblGrid>
              <a:tr h="454783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9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</a:rPr>
                        <a:t>　</a:t>
                      </a:r>
                    </a:p>
                  </a:txBody>
                  <a:tcPr marL="7144" marR="7144" marT="714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3">
                  <a:txBody>
                    <a:bodyPr/>
                    <a:lstStyle/>
                    <a:p>
                      <a:r>
                        <a:rPr kumimoji="1" lang="en-US" altLang="ja-JP" sz="9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</a:rPr>
                        <a:t>Common iliac lymph node metastasis</a:t>
                      </a:r>
                    </a:p>
                  </a:txBody>
                  <a:tcPr marL="7144" marR="7144" marT="714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2000" b="1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ＭＳ Ｐゴシック" panose="020B0600070205080204" pitchFamily="34" charset="-128"/>
                        <a:ea typeface="ＭＳ Ｐゴシック" panose="020B0600070205080204" pitchFamily="34" charset="-128"/>
                      </a:endParaRPr>
                    </a:p>
                  </a:txBody>
                  <a:tcPr marL="9525" marR="9525" marT="95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9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</a:rPr>
                        <a:t>Total pelvic lymph node metastasis</a:t>
                      </a:r>
                      <a:endParaRPr kumimoji="1" lang="ja-JP" altLang="en-US" sz="9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</a:endParaRPr>
                    </a:p>
                  </a:txBody>
                  <a:tcPr marL="7144" marR="7144" marT="7144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2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</a:endParaRPr>
                    </a:p>
                  </a:txBody>
                  <a:tcPr marL="9525" marR="9525" marT="9525" marB="0" anchor="ctr" horzOverflow="overflow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71263123"/>
                  </a:ext>
                </a:extLst>
              </a:tr>
              <a:tr h="447718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9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</a:rPr>
                        <a:t>　</a:t>
                      </a:r>
                    </a:p>
                  </a:txBody>
                  <a:tcPr marL="7144" marR="7144" marT="7144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9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</a:rPr>
                        <a:t>positive (n=3)</a:t>
                      </a:r>
                    </a:p>
                  </a:txBody>
                  <a:tcPr marL="7144" marR="7144" marT="7144" marB="0" anchor="ctr" horzOverflow="overflow">
                    <a:lnL>
                      <a:noFill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9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</a:rPr>
                        <a:t>negative (n=59)</a:t>
                      </a:r>
                    </a:p>
                  </a:txBody>
                  <a:tcPr marL="7144" marR="7144" marT="7144" marB="0" anchor="ctr" horzOverflow="overflow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9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</a:rPr>
                        <a:t>positive (n=13)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9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</a:rPr>
                        <a:t>negative (n=49)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12910550"/>
                  </a:ext>
                </a:extLst>
              </a:tr>
              <a:tr h="447718">
                <a:tc gridSpan="2"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9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</a:rPr>
                        <a:t>Tumor size (mm)</a:t>
                      </a:r>
                    </a:p>
                  </a:txBody>
                  <a:tcPr marL="7144" marR="7144" marT="7144" marB="0" anchor="ctr" horzOverflow="overflow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en-US" altLang="ja-JP" sz="12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</a:endParaRPr>
                    </a:p>
                  </a:txBody>
                  <a:tcPr marL="9525" marR="9525" marT="9525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en-US" altLang="ja-JP" sz="9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</a:endParaRPr>
                    </a:p>
                  </a:txBody>
                  <a:tcPr marL="7144" marR="7144" marT="7144" marB="0" anchor="ctr" horzOverflow="overflow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9pPr>
                    </a:lstStyle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ja-JP" altLang="en-US" sz="900" b="0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</a:rPr>
                        <a:t>　</a:t>
                      </a:r>
                    </a:p>
                  </a:txBody>
                  <a:tcPr marL="7144" marR="7144" marT="7144" marB="0" anchor="ctr" horzOverflow="overflow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9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</a:endParaRP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9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Meiryo" panose="020B0604030504040204" pitchFamily="34" charset="-128"/>
                        <a:ea typeface="Meiryo" panose="020B0604030504040204" pitchFamily="34" charset="-128"/>
                      </a:endParaRP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96862527"/>
                  </a:ext>
                </a:extLst>
              </a:tr>
              <a:tr h="447718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900" b="0" i="0" u="sng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</a:rPr>
                        <a:t>&lt; </a:t>
                      </a:r>
                      <a:r>
                        <a:rPr kumimoji="1" lang="en-US" altLang="ja-JP" sz="9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</a:rPr>
                        <a:t>40 (n=42)</a:t>
                      </a:r>
                    </a:p>
                  </a:txBody>
                  <a:tcPr marL="7144" marR="7144" marT="7144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900" b="0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</a:rPr>
                        <a:t>1</a:t>
                      </a:r>
                      <a:r>
                        <a:rPr kumimoji="1" lang="en-US" altLang="ja-JP" sz="9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</a:rPr>
                        <a:t> </a:t>
                      </a:r>
                    </a:p>
                  </a:txBody>
                  <a:tcPr marL="7144" marR="7144" marT="7144" marB="0" anchor="ctr" horzOverflow="overflow">
                    <a:lnL>
                      <a:noFill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9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</a:rPr>
                        <a:t>41</a:t>
                      </a:r>
                    </a:p>
                  </a:txBody>
                  <a:tcPr marL="7144" marR="7144" marT="7144" marB="0" anchor="ctr" horzOverflow="overflow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9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</a:rPr>
                        <a:t>7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9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</a:rPr>
                        <a:t>35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32747034"/>
                  </a:ext>
                </a:extLst>
              </a:tr>
              <a:tr h="447718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9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</a:rPr>
                        <a:t>&gt; 40 (n=20)</a:t>
                      </a:r>
                    </a:p>
                  </a:txBody>
                  <a:tcPr marL="7144" marR="7144" marT="7144" marB="0" anchor="ctr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9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</a:rPr>
                        <a:t>2 </a:t>
                      </a:r>
                    </a:p>
                  </a:txBody>
                  <a:tcPr marL="7144" marR="7144" marT="7144" marB="0" anchor="ctr" horzOverflow="overflow">
                    <a:lnL>
                      <a:noFill/>
                    </a:lnL>
                    <a:lnR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8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4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 sz="200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 kumimoji="1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ＭＳ Ｐゴシック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9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</a:rPr>
                        <a:t>18</a:t>
                      </a:r>
                    </a:p>
                  </a:txBody>
                  <a:tcPr marL="7144" marR="7144" marT="7144" marB="0" anchor="ctr" horzOverflow="overflow">
                    <a:lnL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9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</a:rPr>
                        <a:t>6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9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Meiryo" panose="020B0604030504040204" pitchFamily="34" charset="-128"/>
                          <a:ea typeface="Meiryo" panose="020B0604030504040204" pitchFamily="34" charset="-128"/>
                        </a:rPr>
                        <a:t>14</a:t>
                      </a:r>
                    </a:p>
                  </a:txBody>
                  <a:tcPr marL="7144" marR="7144" marT="7144" marB="0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61530515"/>
                  </a:ext>
                </a:extLst>
              </a:tr>
            </a:tbl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41621768-9D59-4944-85EA-9E7F16DFAC2A}"/>
              </a:ext>
            </a:extLst>
          </p:cNvPr>
          <p:cNvSpPr txBox="1"/>
          <p:nvPr/>
        </p:nvSpPr>
        <p:spPr>
          <a:xfrm>
            <a:off x="189706" y="201092"/>
            <a:ext cx="23712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/>
              <a:t>Supplementary Table 1</a:t>
            </a:r>
            <a:endParaRPr lang="ja-JP" altLang="en-US" b="1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AED9F0EE-29A9-E24D-BEAC-A3F672CE2EF2}"/>
              </a:ext>
            </a:extLst>
          </p:cNvPr>
          <p:cNvSpPr txBox="1"/>
          <p:nvPr/>
        </p:nvSpPr>
        <p:spPr>
          <a:xfrm>
            <a:off x="524933" y="5366879"/>
            <a:ext cx="5915101" cy="19543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/>
              <a:t>For lymph node mapping, 62 consecutive patients treated with surgery in our hospital (between April 2002 and September 2008) were evaluated. The patients were all lymph node negative on pre-surgical CT scans and were treated with radical hysterectomy and pelvic lymphadenectomy. Pathologically-positive lymph nodes were counted in the surgical specimens. Metastasis in the  common iliac lymph node in stage I-II squamous cell carcinoma was found in 3 of 62 patients (4.8%); however, for those with a tumor size ≤ 4 cm, there was only 1 case in 42 patients (2.4%), suggesting a low incidence of common iliac lymph metastasis in tumors less ≤ 4 cm. (Information extracted from Ref. 5 (Noda, SE, Ohno, T, </a:t>
            </a:r>
            <a:r>
              <a:rPr lang="en-US" altLang="ja-JP" sz="1100" dirty="0" err="1"/>
              <a:t>Wakatsuki</a:t>
            </a:r>
            <a:r>
              <a:rPr lang="en-US" altLang="ja-JP" sz="1100" dirty="0"/>
              <a:t>, M, et al) with the permission of the authors).  The common iliac lymph node region can be excluded from external-beam radiotherapy in early-stage cervical cancer (23rd Annual Meeting of Japanese Society for Radiation Oncology, Tokyo, 2010. Abstract O-273).</a:t>
            </a:r>
            <a:endParaRPr kumimoji="1" lang="ja-JP" altLang="en-US" sz="1100" dirty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40309676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047</TotalTime>
  <Words>249</Words>
  <Application>Microsoft Macintosh PowerPoint</Application>
  <PresentationFormat>A4 210 x 297 mm</PresentationFormat>
  <Paragraphs>2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Meiryo</vt:lpstr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uya Yoshimoto</dc:creator>
  <cp:lastModifiedBy>吉本 由哉</cp:lastModifiedBy>
  <cp:revision>59</cp:revision>
  <cp:lastPrinted>2021-02-13T04:40:57Z</cp:lastPrinted>
  <dcterms:created xsi:type="dcterms:W3CDTF">2021-02-13T04:40:07Z</dcterms:created>
  <dcterms:modified xsi:type="dcterms:W3CDTF">2021-12-16T12:43:34Z</dcterms:modified>
</cp:coreProperties>
</file>